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587A31-18A1-48D8-BD3F-2A62724B27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931EE-B790-4D96-BDB7-5BD0CE6058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C0EED-58C4-4DF5-9DFC-3D55083929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C13722-C600-4CEE-A98F-6724E4A017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60FEA-7E7C-42B7-8B4A-791FEBDA79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449E36-1741-4BAD-B0B9-B628461F02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22832C-7CC9-4FCF-9226-91D2A9B0F1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A25F0B-94BF-4A13-9C59-E913A13C25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CF353-AC6F-4941-926B-40C9DA85F5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7E1261-97EC-4A7D-8236-7637EBF97A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C26EB-9797-4E0C-AD56-B7EC3E6B82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541F1-A101-4875-A132-2F7B6A42FD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D43C0F-AD81-4A41-9F39-34429AA08B98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8FF4E5-6B44-4863-A00E-D455A1DD83BA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7" descr="fD.jpg"/>
          <p:cNvPicPr/>
          <p:nvPr/>
        </p:nvPicPr>
        <p:blipFill>
          <a:blip r:embed="rId1"/>
          <a:stretch/>
        </p:blipFill>
        <p:spPr>
          <a:xfrm>
            <a:off x="4427640" y="3757680"/>
            <a:ext cx="3998880" cy="3100320"/>
          </a:xfrm>
          <a:prstGeom prst="rect">
            <a:avLst/>
          </a:prstGeom>
          <a:ln w="0">
            <a:noFill/>
          </a:ln>
        </p:spPr>
      </p:pic>
      <p:pic>
        <p:nvPicPr>
          <p:cNvPr id="42" name="Grafik 8" descr="fA.jpg"/>
          <p:cNvPicPr/>
          <p:nvPr/>
        </p:nvPicPr>
        <p:blipFill>
          <a:blip r:embed="rId2"/>
          <a:stretch/>
        </p:blipFill>
        <p:spPr>
          <a:xfrm>
            <a:off x="468360" y="1052640"/>
            <a:ext cx="3568680" cy="2954160"/>
          </a:xfrm>
          <a:prstGeom prst="rect">
            <a:avLst/>
          </a:prstGeom>
          <a:ln w="0">
            <a:noFill/>
          </a:ln>
        </p:spPr>
      </p:pic>
      <p:pic>
        <p:nvPicPr>
          <p:cNvPr id="43" name="Grafik 10" descr="fC.jpg"/>
          <p:cNvPicPr/>
          <p:nvPr/>
        </p:nvPicPr>
        <p:blipFill>
          <a:blip r:embed="rId3"/>
          <a:stretch/>
        </p:blipFill>
        <p:spPr>
          <a:xfrm>
            <a:off x="4859280" y="981000"/>
            <a:ext cx="3533760" cy="2919600"/>
          </a:xfrm>
          <a:prstGeom prst="rect">
            <a:avLst/>
          </a:prstGeom>
          <a:ln w="0">
            <a:noFill/>
          </a:ln>
        </p:spPr>
      </p:pic>
      <p:pic>
        <p:nvPicPr>
          <p:cNvPr id="44" name="Grafik 11" descr="fB.jpg"/>
          <p:cNvPicPr/>
          <p:nvPr/>
        </p:nvPicPr>
        <p:blipFill>
          <a:blip r:embed="rId4"/>
          <a:stretch/>
        </p:blipFill>
        <p:spPr>
          <a:xfrm>
            <a:off x="0" y="3684600"/>
            <a:ext cx="3998880" cy="3173400"/>
          </a:xfrm>
          <a:prstGeom prst="rect">
            <a:avLst/>
          </a:prstGeom>
          <a:ln w="0">
            <a:noFill/>
          </a:ln>
        </p:spPr>
      </p:pic>
      <p:sp>
        <p:nvSpPr>
          <p:cNvPr id="45" name="Textfeld 13"/>
          <p:cNvSpPr/>
          <p:nvPr/>
        </p:nvSpPr>
        <p:spPr>
          <a:xfrm>
            <a:off x="233280" y="0"/>
            <a:ext cx="8675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Supplementary material f. 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Differences in the percentage of naive and activated T cells between subgroups of HIV-1-infected patients living in Nouna (rural) and Ouagadougou (urban). Only patients with similar CD4</a:t>
            </a:r>
            <a:r>
              <a:rPr b="0" lang="de-DE" sz="12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de-DE" sz="1200" spc="-1" strike="noStrike">
                <a:solidFill>
                  <a:srgbClr val="000000"/>
                </a:solidFill>
                <a:latin typeface="Times New Roman"/>
              </a:rPr>
              <a:t> T cell counts or similar HIV-1-plasma viral load levels were compar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feld 5"/>
          <p:cNvSpPr/>
          <p:nvPr/>
        </p:nvSpPr>
        <p:spPr>
          <a:xfrm>
            <a:off x="255240" y="838080"/>
            <a:ext cx="4312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CD4 count between 200 and 399 cells/mm</a:t>
            </a:r>
            <a:r>
              <a:rPr b="1" lang="de-DE" sz="18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feld 6"/>
          <p:cNvSpPr/>
          <p:nvPr/>
        </p:nvSpPr>
        <p:spPr>
          <a:xfrm>
            <a:off x="4577040" y="776160"/>
            <a:ext cx="464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Viral load between 4.0 and 5.9 log10 copies/m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7T13:07:13Z</dcterms:created>
  <dc:creator>Fabrice Tiba</dc:creator>
  <dc:description/>
  <dc:language>en-US</dc:language>
  <cp:lastModifiedBy>LG</cp:lastModifiedBy>
  <dcterms:modified xsi:type="dcterms:W3CDTF">2011-11-07T17:17:16Z</dcterms:modified>
  <cp:revision>4</cp:revision>
  <dc:subject/>
  <dc:title>Folie 1</dc:title>
</cp:coreProperties>
</file>